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11.png" ContentType="image/png"/>
  <Override PartName="/ppt/media/image10.wmf" ContentType="image/x-wmf"/>
  <Override PartName="/ppt/media/image2.png" ContentType="image/png"/>
  <Override PartName="/ppt/media/image7.png" ContentType="image/png"/>
  <Override PartName="/ppt/embeddings/oleObject1.xlsx" ContentType="application/vnd.openxmlformats-officedocument.spreadsheetml.shee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6858000" cy="9144000"/>
  <p:notesSz cx="9144000" cy="6858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D3E177-7CEA-4BE5-B369-87628BD06B6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3A372C-6486-4A02-A4E8-83F54071B10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DDDC33-A90D-445F-880F-A3E3F7C9244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7F2E2F-0EB9-4DD1-8093-C8137741252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8B790C-8D27-4191-B9FA-8F7B2942EF2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1A190F-14BA-4B79-8392-1838808015E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13117B-870E-447D-B3E2-06EA95D9B5E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E8A674-1CAD-4445-9E2B-360743C2679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BCD0F3-86AC-408B-A807-8F2F50EA6A6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9F8389-88DE-4082-A2D6-EDC2455A6EC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96CF19-AA4C-4529-B7AA-B64EBB30DEC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FF6DC7-98D0-41EA-83D1-B8E5DC81541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1988088-3336-4AC0-A425-C0005B595018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package" Target="../embeddings/oleObject1.xlsx"/><Relationship Id="rId3" Type="http://schemas.openxmlformats.org/officeDocument/2006/relationships/image" Target="../media/image10.wmf"/><Relationship Id="rId4" Type="http://schemas.openxmlformats.org/officeDocument/2006/relationships/image" Target="../media/image11.png"/><Relationship Id="rId5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image" Target="../media/image13.png"/><Relationship Id="rId3" Type="http://schemas.openxmlformats.org/officeDocument/2006/relationships/image" Target="../media/image14.png"/><Relationship Id="rId4" Type="http://schemas.openxmlformats.org/officeDocument/2006/relationships/image" Target="../media/image15.png"/><Relationship Id="rId5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image" Target="../media/image17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71"/>
          <p:cNvGrpSpPr/>
          <p:nvPr/>
        </p:nvGrpSpPr>
        <p:grpSpPr>
          <a:xfrm>
            <a:off x="228600" y="666720"/>
            <a:ext cx="1814760" cy="1412640"/>
            <a:chOff x="228600" y="666720"/>
            <a:chExt cx="1814760" cy="1412640"/>
          </a:xfrm>
        </p:grpSpPr>
        <p:grpSp>
          <p:nvGrpSpPr>
            <p:cNvPr id="42" name="Group 1"/>
            <p:cNvGrpSpPr/>
            <p:nvPr/>
          </p:nvGrpSpPr>
          <p:grpSpPr>
            <a:xfrm>
              <a:off x="228600" y="666720"/>
              <a:ext cx="1740600" cy="1412640"/>
              <a:chOff x="228600" y="666720"/>
              <a:chExt cx="1740600" cy="1412640"/>
            </a:xfrm>
          </p:grpSpPr>
          <p:pic>
            <p:nvPicPr>
              <p:cNvPr id="43" name="Chart 61" descr=""/>
              <p:cNvPicPr/>
              <p:nvPr/>
            </p:nvPicPr>
            <p:blipFill>
              <a:blip r:embed="rId1"/>
              <a:stretch/>
            </p:blipFill>
            <p:spPr>
              <a:xfrm>
                <a:off x="228600" y="666720"/>
                <a:ext cx="1740600" cy="13366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4" name="Text Box 13"/>
              <p:cNvSpPr/>
              <p:nvPr/>
            </p:nvSpPr>
            <p:spPr>
              <a:xfrm>
                <a:off x="839880" y="1863720"/>
                <a:ext cx="935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D40 µg/10</a:t>
                </a:r>
                <a:r>
                  <a:rPr b="1" lang="en-US" sz="800" spc="-1" strike="noStrike" baseline="30000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6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ell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Text Box 13"/>
              <p:cNvSpPr/>
              <p:nvPr/>
            </p:nvSpPr>
            <p:spPr>
              <a:xfrm>
                <a:off x="718560" y="1741680"/>
                <a:ext cx="232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Text Box 13"/>
              <p:cNvSpPr/>
              <p:nvPr/>
            </p:nvSpPr>
            <p:spPr>
              <a:xfrm>
                <a:off x="831240" y="1741680"/>
                <a:ext cx="362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.2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Text Box 13"/>
              <p:cNvSpPr/>
              <p:nvPr/>
            </p:nvSpPr>
            <p:spPr>
              <a:xfrm>
                <a:off x="1063080" y="1741680"/>
                <a:ext cx="3103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.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Text Box 13"/>
              <p:cNvSpPr/>
              <p:nvPr/>
            </p:nvSpPr>
            <p:spPr>
              <a:xfrm>
                <a:off x="1289520" y="1741680"/>
                <a:ext cx="232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Text Box 13"/>
              <p:cNvSpPr/>
              <p:nvPr/>
            </p:nvSpPr>
            <p:spPr>
              <a:xfrm>
                <a:off x="1523520" y="1741680"/>
                <a:ext cx="232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Text Box 13"/>
              <p:cNvSpPr/>
              <p:nvPr/>
            </p:nvSpPr>
            <p:spPr>
              <a:xfrm>
                <a:off x="1725120" y="1741680"/>
                <a:ext cx="232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1" name="TextBox 12"/>
            <p:cNvSpPr/>
            <p:nvPr/>
          </p:nvSpPr>
          <p:spPr>
            <a:xfrm>
              <a:off x="1710360" y="935640"/>
              <a:ext cx="333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*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2" name="Group 57"/>
          <p:cNvGrpSpPr/>
          <p:nvPr/>
        </p:nvGrpSpPr>
        <p:grpSpPr>
          <a:xfrm>
            <a:off x="58680" y="1981080"/>
            <a:ext cx="6791760" cy="2362320"/>
            <a:chOff x="58680" y="1981080"/>
            <a:chExt cx="6791760" cy="2362320"/>
          </a:xfrm>
        </p:grpSpPr>
        <p:grpSp>
          <p:nvGrpSpPr>
            <p:cNvPr id="53" name="Group 30"/>
            <p:cNvGrpSpPr/>
            <p:nvPr/>
          </p:nvGrpSpPr>
          <p:grpSpPr>
            <a:xfrm>
              <a:off x="3657600" y="1981080"/>
              <a:ext cx="3192840" cy="2327040"/>
              <a:chOff x="3657600" y="1981080"/>
              <a:chExt cx="3192840" cy="2327040"/>
            </a:xfrm>
          </p:grpSpPr>
          <p:pic>
            <p:nvPicPr>
              <p:cNvPr id="54" name="Chart 99" descr=""/>
              <p:cNvPicPr/>
              <p:nvPr/>
            </p:nvPicPr>
            <p:blipFill>
              <a:blip r:embed="rId2"/>
              <a:stretch/>
            </p:blipFill>
            <p:spPr>
              <a:xfrm>
                <a:off x="3785400" y="2132640"/>
                <a:ext cx="3054240" cy="21754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5" name="Text Box 10"/>
              <p:cNvSpPr/>
              <p:nvPr/>
            </p:nvSpPr>
            <p:spPr>
              <a:xfrm>
                <a:off x="4877280" y="4048920"/>
                <a:ext cx="946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D40 µg/10</a:t>
                </a:r>
                <a:r>
                  <a:rPr b="1" lang="en-US" sz="800" spc="-1" strike="noStrike" baseline="30000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6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cell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Text Box 23"/>
              <p:cNvSpPr/>
              <p:nvPr/>
            </p:nvSpPr>
            <p:spPr>
              <a:xfrm rot="16200000">
                <a:off x="3233160" y="2958840"/>
                <a:ext cx="1064520" cy="21564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IL-12 (pg/ml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57" name="Group 20"/>
              <p:cNvGrpSpPr/>
              <p:nvPr/>
            </p:nvGrpSpPr>
            <p:grpSpPr>
              <a:xfrm>
                <a:off x="4294440" y="3910680"/>
                <a:ext cx="1943280" cy="215640"/>
                <a:chOff x="4294440" y="3910680"/>
                <a:chExt cx="1943280" cy="215640"/>
              </a:xfrm>
            </p:grpSpPr>
            <p:sp>
              <p:nvSpPr>
                <p:cNvPr id="58" name="TextBox 21"/>
                <p:cNvSpPr/>
                <p:nvPr/>
              </p:nvSpPr>
              <p:spPr>
                <a:xfrm>
                  <a:off x="4294440" y="3910680"/>
                  <a:ext cx="2325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" name="TextBox 22"/>
                <p:cNvSpPr/>
                <p:nvPr/>
              </p:nvSpPr>
              <p:spPr>
                <a:xfrm>
                  <a:off x="4669200" y="3910680"/>
                  <a:ext cx="31032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0.5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" name="TextBox 23"/>
                <p:cNvSpPr/>
                <p:nvPr/>
              </p:nvSpPr>
              <p:spPr>
                <a:xfrm>
                  <a:off x="4975200" y="3910680"/>
                  <a:ext cx="2325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1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" name="TextBox 24"/>
                <p:cNvSpPr/>
                <p:nvPr/>
              </p:nvSpPr>
              <p:spPr>
                <a:xfrm>
                  <a:off x="5322600" y="3910680"/>
                  <a:ext cx="2325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2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" name="TextBox 25"/>
                <p:cNvSpPr/>
                <p:nvPr/>
              </p:nvSpPr>
              <p:spPr>
                <a:xfrm>
                  <a:off x="5663880" y="3910680"/>
                  <a:ext cx="2325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4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" name="TextBox 26"/>
                <p:cNvSpPr/>
                <p:nvPr/>
              </p:nvSpPr>
              <p:spPr>
                <a:xfrm>
                  <a:off x="6005160" y="3910680"/>
                  <a:ext cx="2325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8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64" name="TextBox 28"/>
              <p:cNvSpPr/>
              <p:nvPr/>
            </p:nvSpPr>
            <p:spPr>
              <a:xfrm>
                <a:off x="5994720" y="1981080"/>
                <a:ext cx="855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TLR-4L (ng/ml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5" name="TextBox 60"/>
            <p:cNvSpPr/>
            <p:nvPr/>
          </p:nvSpPr>
          <p:spPr>
            <a:xfrm>
              <a:off x="58680" y="2392200"/>
              <a:ext cx="322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6" name="Group 27"/>
            <p:cNvGrpSpPr/>
            <p:nvPr/>
          </p:nvGrpSpPr>
          <p:grpSpPr>
            <a:xfrm>
              <a:off x="304560" y="2185200"/>
              <a:ext cx="3411000" cy="2158200"/>
              <a:chOff x="304560" y="2185200"/>
              <a:chExt cx="3411000" cy="2158200"/>
            </a:xfrm>
          </p:grpSpPr>
          <p:pic>
            <p:nvPicPr>
              <p:cNvPr id="67" name="Chart 87" descr=""/>
              <p:cNvPicPr/>
              <p:nvPr/>
            </p:nvPicPr>
            <p:blipFill>
              <a:blip r:embed="rId3"/>
              <a:stretch/>
            </p:blipFill>
            <p:spPr>
              <a:xfrm>
                <a:off x="340920" y="2334240"/>
                <a:ext cx="3139560" cy="20091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8" name="Text Box 13"/>
              <p:cNvSpPr/>
              <p:nvPr/>
            </p:nvSpPr>
            <p:spPr>
              <a:xfrm>
                <a:off x="1260360" y="4092840"/>
                <a:ext cx="920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D40 µg/10</a:t>
                </a:r>
                <a:r>
                  <a:rPr b="1" lang="en-US" sz="800" spc="-1" strike="noStrike" baseline="30000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6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ell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Text Box 23"/>
              <p:cNvSpPr/>
              <p:nvPr/>
            </p:nvSpPr>
            <p:spPr>
              <a:xfrm rot="16200000">
                <a:off x="-127800" y="3051720"/>
                <a:ext cx="1080720" cy="21564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IL-6 (pg/ml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70" name="Group 19"/>
              <p:cNvGrpSpPr/>
              <p:nvPr/>
            </p:nvGrpSpPr>
            <p:grpSpPr>
              <a:xfrm>
                <a:off x="842400" y="3946320"/>
                <a:ext cx="2064960" cy="215640"/>
                <a:chOff x="842400" y="3946320"/>
                <a:chExt cx="2064960" cy="215640"/>
              </a:xfrm>
            </p:grpSpPr>
            <p:sp>
              <p:nvSpPr>
                <p:cNvPr id="71" name="TextBox 11"/>
                <p:cNvSpPr/>
                <p:nvPr/>
              </p:nvSpPr>
              <p:spPr>
                <a:xfrm>
                  <a:off x="842400" y="3946320"/>
                  <a:ext cx="2325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" name="TextBox 12"/>
                <p:cNvSpPr/>
                <p:nvPr/>
              </p:nvSpPr>
              <p:spPr>
                <a:xfrm>
                  <a:off x="1202400" y="3946320"/>
                  <a:ext cx="31032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0.5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" name="TextBox 13"/>
                <p:cNvSpPr/>
                <p:nvPr/>
              </p:nvSpPr>
              <p:spPr>
                <a:xfrm>
                  <a:off x="1539360" y="3946320"/>
                  <a:ext cx="2325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1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" name="TextBox 14"/>
                <p:cNvSpPr/>
                <p:nvPr/>
              </p:nvSpPr>
              <p:spPr>
                <a:xfrm>
                  <a:off x="1962720" y="3946320"/>
                  <a:ext cx="2325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2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" name="TextBox 17"/>
                <p:cNvSpPr/>
                <p:nvPr/>
              </p:nvSpPr>
              <p:spPr>
                <a:xfrm>
                  <a:off x="2325240" y="3946320"/>
                  <a:ext cx="2325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4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" name="TextBox 18"/>
                <p:cNvSpPr/>
                <p:nvPr/>
              </p:nvSpPr>
              <p:spPr>
                <a:xfrm>
                  <a:off x="2674800" y="3946320"/>
                  <a:ext cx="2325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8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77" name="TextBox 27"/>
              <p:cNvSpPr/>
              <p:nvPr/>
            </p:nvSpPr>
            <p:spPr>
              <a:xfrm>
                <a:off x="2859840" y="2185200"/>
                <a:ext cx="855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TLR-4L (ng/ml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8" name="TextBox 34"/>
            <p:cNvSpPr/>
            <p:nvPr/>
          </p:nvSpPr>
          <p:spPr>
            <a:xfrm>
              <a:off x="3072240" y="2515680"/>
              <a:ext cx="362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.2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TextBox 35"/>
            <p:cNvSpPr/>
            <p:nvPr/>
          </p:nvSpPr>
          <p:spPr>
            <a:xfrm>
              <a:off x="3078360" y="2674080"/>
              <a:ext cx="310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.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TextBox 36"/>
            <p:cNvSpPr/>
            <p:nvPr/>
          </p:nvSpPr>
          <p:spPr>
            <a:xfrm>
              <a:off x="3064680" y="2829960"/>
              <a:ext cx="23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TextBox 37"/>
            <p:cNvSpPr/>
            <p:nvPr/>
          </p:nvSpPr>
          <p:spPr>
            <a:xfrm>
              <a:off x="6198480" y="2406240"/>
              <a:ext cx="388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.2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TextBox 39"/>
            <p:cNvSpPr/>
            <p:nvPr/>
          </p:nvSpPr>
          <p:spPr>
            <a:xfrm>
              <a:off x="6175440" y="2578680"/>
              <a:ext cx="33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.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TextBox 40"/>
            <p:cNvSpPr/>
            <p:nvPr/>
          </p:nvSpPr>
          <p:spPr>
            <a:xfrm>
              <a:off x="6174360" y="2766600"/>
              <a:ext cx="258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Straight Connector 71"/>
            <p:cNvSpPr/>
            <p:nvPr/>
          </p:nvSpPr>
          <p:spPr>
            <a:xfrm flipV="1">
              <a:off x="2259000" y="2636280"/>
              <a:ext cx="0" cy="90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Straight Connector 72"/>
            <p:cNvSpPr/>
            <p:nvPr/>
          </p:nvSpPr>
          <p:spPr>
            <a:xfrm>
              <a:off x="2259000" y="2636640"/>
              <a:ext cx="1728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TextBox 46"/>
            <p:cNvSpPr/>
            <p:nvPr/>
          </p:nvSpPr>
          <p:spPr>
            <a:xfrm>
              <a:off x="2187720" y="2464560"/>
              <a:ext cx="344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***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Straight Connector 75"/>
            <p:cNvSpPr/>
            <p:nvPr/>
          </p:nvSpPr>
          <p:spPr>
            <a:xfrm flipV="1">
              <a:off x="2314440" y="2714040"/>
              <a:ext cx="0" cy="447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Straight Connector 76"/>
            <p:cNvSpPr/>
            <p:nvPr/>
          </p:nvSpPr>
          <p:spPr>
            <a:xfrm>
              <a:off x="2316240" y="2714400"/>
              <a:ext cx="1396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TextBox 51"/>
            <p:cNvSpPr/>
            <p:nvPr/>
          </p:nvSpPr>
          <p:spPr>
            <a:xfrm>
              <a:off x="2276640" y="2599200"/>
              <a:ext cx="344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**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Straight Connector 78"/>
            <p:cNvSpPr/>
            <p:nvPr/>
          </p:nvSpPr>
          <p:spPr>
            <a:xfrm flipV="1">
              <a:off x="5649840" y="2407680"/>
              <a:ext cx="0" cy="90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Straight Connector 79"/>
            <p:cNvSpPr/>
            <p:nvPr/>
          </p:nvSpPr>
          <p:spPr>
            <a:xfrm>
              <a:off x="5649840" y="2408040"/>
              <a:ext cx="1728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TextBox 54"/>
            <p:cNvSpPr/>
            <p:nvPr/>
          </p:nvSpPr>
          <p:spPr>
            <a:xfrm>
              <a:off x="5607000" y="2249280"/>
              <a:ext cx="344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**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Straight Connector 81"/>
            <p:cNvSpPr/>
            <p:nvPr/>
          </p:nvSpPr>
          <p:spPr>
            <a:xfrm flipV="1">
              <a:off x="5707080" y="2486880"/>
              <a:ext cx="0" cy="446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Straight Connector 82"/>
            <p:cNvSpPr/>
            <p:nvPr/>
          </p:nvSpPr>
          <p:spPr>
            <a:xfrm>
              <a:off x="5707080" y="2487240"/>
              <a:ext cx="1396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TextBox 57"/>
            <p:cNvSpPr/>
            <p:nvPr/>
          </p:nvSpPr>
          <p:spPr>
            <a:xfrm>
              <a:off x="5650200" y="2366640"/>
              <a:ext cx="344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**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6" name="TextBox 34"/>
          <p:cNvSpPr/>
          <p:nvPr/>
        </p:nvSpPr>
        <p:spPr>
          <a:xfrm>
            <a:off x="66960" y="0"/>
            <a:ext cx="964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Box 69"/>
          <p:cNvSpPr/>
          <p:nvPr/>
        </p:nvSpPr>
        <p:spPr>
          <a:xfrm>
            <a:off x="111240" y="304920"/>
            <a:ext cx="303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8" name="Group 10"/>
          <p:cNvGrpSpPr/>
          <p:nvPr/>
        </p:nvGrpSpPr>
        <p:grpSpPr>
          <a:xfrm>
            <a:off x="2023920" y="557280"/>
            <a:ext cx="2028960" cy="1503720"/>
            <a:chOff x="2023920" y="557280"/>
            <a:chExt cx="2028960" cy="1503720"/>
          </a:xfrm>
        </p:grpSpPr>
        <p:pic>
          <p:nvPicPr>
            <p:cNvPr id="99" name="Chart 73" descr=""/>
            <p:cNvPicPr/>
            <p:nvPr/>
          </p:nvPicPr>
          <p:blipFill>
            <a:blip r:embed="rId4"/>
            <a:stretch/>
          </p:blipFill>
          <p:spPr>
            <a:xfrm>
              <a:off x="2023920" y="557280"/>
              <a:ext cx="2028960" cy="147456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00" name="Group 43"/>
            <p:cNvGrpSpPr/>
            <p:nvPr/>
          </p:nvGrpSpPr>
          <p:grpSpPr>
            <a:xfrm>
              <a:off x="2484000" y="1703880"/>
              <a:ext cx="1482840" cy="357120"/>
              <a:chOff x="2484000" y="1703880"/>
              <a:chExt cx="1482840" cy="357120"/>
            </a:xfrm>
          </p:grpSpPr>
          <p:sp>
            <p:nvSpPr>
              <p:cNvPr id="101" name="Text Box 13"/>
              <p:cNvSpPr/>
              <p:nvPr/>
            </p:nvSpPr>
            <p:spPr>
              <a:xfrm>
                <a:off x="2688480" y="1845360"/>
                <a:ext cx="1260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D80 µg/10</a:t>
                </a:r>
                <a:r>
                  <a:rPr b="1" lang="en-US" sz="800" spc="-1" strike="noStrike" baseline="30000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6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ell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Text Box 13"/>
              <p:cNvSpPr/>
              <p:nvPr/>
            </p:nvSpPr>
            <p:spPr>
              <a:xfrm>
                <a:off x="2484000" y="1708920"/>
                <a:ext cx="232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Text Box 13"/>
              <p:cNvSpPr/>
              <p:nvPr/>
            </p:nvSpPr>
            <p:spPr>
              <a:xfrm>
                <a:off x="2643840" y="1708920"/>
                <a:ext cx="362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.2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Text Box 13"/>
              <p:cNvSpPr/>
              <p:nvPr/>
            </p:nvSpPr>
            <p:spPr>
              <a:xfrm>
                <a:off x="2954160" y="1708920"/>
                <a:ext cx="3103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.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Text Box 13"/>
              <p:cNvSpPr/>
              <p:nvPr/>
            </p:nvSpPr>
            <p:spPr>
              <a:xfrm>
                <a:off x="3183120" y="1708920"/>
                <a:ext cx="3103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Text Box 13"/>
              <p:cNvSpPr/>
              <p:nvPr/>
            </p:nvSpPr>
            <p:spPr>
              <a:xfrm>
                <a:off x="3483000" y="1708920"/>
                <a:ext cx="232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Text Box 13"/>
              <p:cNvSpPr/>
              <p:nvPr/>
            </p:nvSpPr>
            <p:spPr>
              <a:xfrm>
                <a:off x="3734280" y="1703880"/>
                <a:ext cx="232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08" name="Group 20"/>
          <p:cNvGrpSpPr/>
          <p:nvPr/>
        </p:nvGrpSpPr>
        <p:grpSpPr>
          <a:xfrm>
            <a:off x="4413240" y="533520"/>
            <a:ext cx="2013120" cy="1469880"/>
            <a:chOff x="4413240" y="533520"/>
            <a:chExt cx="2013120" cy="1469880"/>
          </a:xfrm>
        </p:grpSpPr>
        <p:pic>
          <p:nvPicPr>
            <p:cNvPr id="109" name="Chart 83" descr=""/>
            <p:cNvPicPr/>
            <p:nvPr/>
          </p:nvPicPr>
          <p:blipFill>
            <a:blip r:embed="rId5"/>
            <a:stretch/>
          </p:blipFill>
          <p:spPr>
            <a:xfrm>
              <a:off x="4413240" y="533520"/>
              <a:ext cx="2013120" cy="146988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10" name="Group 24"/>
            <p:cNvGrpSpPr/>
            <p:nvPr/>
          </p:nvGrpSpPr>
          <p:grpSpPr>
            <a:xfrm>
              <a:off x="4946400" y="1705680"/>
              <a:ext cx="1456920" cy="215640"/>
              <a:chOff x="4946400" y="1705680"/>
              <a:chExt cx="1456920" cy="215640"/>
            </a:xfrm>
          </p:grpSpPr>
          <p:sp>
            <p:nvSpPr>
              <p:cNvPr id="111" name="Text Box 13"/>
              <p:cNvSpPr/>
              <p:nvPr/>
            </p:nvSpPr>
            <p:spPr>
              <a:xfrm>
                <a:off x="4946400" y="1705680"/>
                <a:ext cx="232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Text Box 13"/>
              <p:cNvSpPr/>
              <p:nvPr/>
            </p:nvSpPr>
            <p:spPr>
              <a:xfrm>
                <a:off x="5087880" y="1705680"/>
                <a:ext cx="362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.2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Text Box 13"/>
              <p:cNvSpPr/>
              <p:nvPr/>
            </p:nvSpPr>
            <p:spPr>
              <a:xfrm>
                <a:off x="5396040" y="1705680"/>
                <a:ext cx="3103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.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Text Box 13"/>
              <p:cNvSpPr/>
              <p:nvPr/>
            </p:nvSpPr>
            <p:spPr>
              <a:xfrm>
                <a:off x="5692320" y="1705680"/>
                <a:ext cx="232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Text Box 13"/>
              <p:cNvSpPr/>
              <p:nvPr/>
            </p:nvSpPr>
            <p:spPr>
              <a:xfrm>
                <a:off x="5931000" y="1705680"/>
                <a:ext cx="232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Text Box 13"/>
              <p:cNvSpPr/>
              <p:nvPr/>
            </p:nvSpPr>
            <p:spPr>
              <a:xfrm>
                <a:off x="6170760" y="1705680"/>
                <a:ext cx="232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117" name="Text Box 13"/>
          <p:cNvSpPr/>
          <p:nvPr/>
        </p:nvSpPr>
        <p:spPr>
          <a:xfrm>
            <a:off x="5105520" y="1851120"/>
            <a:ext cx="1066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D86 µg/10</a:t>
            </a:r>
            <a:r>
              <a:rPr b="1" lang="en-US" sz="8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6</a:t>
            </a: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ell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TextBox 93"/>
          <p:cNvSpPr/>
          <p:nvPr/>
        </p:nvSpPr>
        <p:spPr>
          <a:xfrm>
            <a:off x="57240" y="6897600"/>
            <a:ext cx="6572160" cy="2148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50000"/>
              </a:lnSpc>
              <a:spcBef>
                <a:spcPts val="499"/>
              </a:spcBef>
              <a:spcAft>
                <a:spcPts val="499"/>
              </a:spcAft>
              <a:tabLst>
                <a:tab algn="l" pos="0"/>
                <a:tab algn="l" pos="57240"/>
                <a:tab algn="l" pos="114480"/>
                <a:tab algn="l" pos="228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809960"/>
                <a:tab algn="l" pos="103924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. Signaling of DCs through CD40 but not CD80 and CD86 induces the secretion of IL-12. (A) BMDCs were incubated with different concentration of anti-CD40 Ab, anti-CD80 Ab, and anti-CD86 Ab for 24h. Activation of DCs was assessed by estimating IL-12 in culture SNs through ELISA. (B) DCs were stimulated with different concentrations of C40.T4 for 24h. Later, IL-6 and IL-12 were estimated in the SNs by ELISA. DCs were stimulated through CD40 (4</a:t>
            </a:r>
            <a:r>
              <a:rPr b="0" lang="el-GR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μ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/106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ells ) and TLR-4  (5ng/ml) for 24h. Later, cells were stained for stained for  (C) CD80; (D) CD86; (E) MHCII on CD11c gated population. The data expressed as mean±SD of Integrated Mean fluorescence Intensity (IMFI) computed by multiplying the relative frequency (% positive) of cells expressing a particular molecules with the mean fluorescence intensity (MFI) of that population are representative of two independent similar experiments and each experiment was assayed in triplicates. ‘*’ ‘**’, ‘***’ indicates p&lt;0.05, p&lt;0.01 and p&lt;0.001, respectively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9" name="Group 174"/>
          <p:cNvGrpSpPr/>
          <p:nvPr/>
        </p:nvGrpSpPr>
        <p:grpSpPr>
          <a:xfrm>
            <a:off x="0" y="4581000"/>
            <a:ext cx="2382840" cy="1532160"/>
            <a:chOff x="0" y="4581000"/>
            <a:chExt cx="2382840" cy="1532160"/>
          </a:xfrm>
        </p:grpSpPr>
        <p:pic>
          <p:nvPicPr>
            <p:cNvPr id="120" name="Chart 175" descr=""/>
            <p:cNvPicPr/>
            <p:nvPr/>
          </p:nvPicPr>
          <p:blipFill>
            <a:blip r:embed="rId6"/>
            <a:stretch/>
          </p:blipFill>
          <p:spPr>
            <a:xfrm>
              <a:off x="292320" y="4736160"/>
              <a:ext cx="1865520" cy="1316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1" name="Straight Connector 176"/>
            <p:cNvSpPr/>
            <p:nvPr/>
          </p:nvSpPr>
          <p:spPr>
            <a:xfrm>
              <a:off x="657000" y="4854240"/>
              <a:ext cx="993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TextBox 147"/>
            <p:cNvSpPr/>
            <p:nvPr/>
          </p:nvSpPr>
          <p:spPr>
            <a:xfrm>
              <a:off x="1032120" y="465912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TextBox 149"/>
            <p:cNvSpPr/>
            <p:nvPr/>
          </p:nvSpPr>
          <p:spPr>
            <a:xfrm>
              <a:off x="1387800" y="482976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Straight Connector 179"/>
            <p:cNvSpPr/>
            <p:nvPr/>
          </p:nvSpPr>
          <p:spPr>
            <a:xfrm>
              <a:off x="1332000" y="4991040"/>
              <a:ext cx="341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TextBox 23"/>
            <p:cNvSpPr/>
            <p:nvPr/>
          </p:nvSpPr>
          <p:spPr>
            <a:xfrm>
              <a:off x="397080" y="5906520"/>
              <a:ext cx="5634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Untreated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TextBox 24"/>
            <p:cNvSpPr/>
            <p:nvPr/>
          </p:nvSpPr>
          <p:spPr>
            <a:xfrm>
              <a:off x="900720" y="5905440"/>
              <a:ext cx="3970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D4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TextBox 25"/>
            <p:cNvSpPr/>
            <p:nvPr/>
          </p:nvSpPr>
          <p:spPr>
            <a:xfrm>
              <a:off x="1194840" y="5912640"/>
              <a:ext cx="4366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TLR-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TextBox 26"/>
            <p:cNvSpPr/>
            <p:nvPr/>
          </p:nvSpPr>
          <p:spPr>
            <a:xfrm>
              <a:off x="1519920" y="5908320"/>
              <a:ext cx="4597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40.T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TextBox 27"/>
            <p:cNvSpPr/>
            <p:nvPr/>
          </p:nvSpPr>
          <p:spPr>
            <a:xfrm>
              <a:off x="1828080" y="5909760"/>
              <a:ext cx="5547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sotype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TextBox 152"/>
            <p:cNvSpPr/>
            <p:nvPr/>
          </p:nvSpPr>
          <p:spPr>
            <a:xfrm rot="16200000">
              <a:off x="-495360" y="5076720"/>
              <a:ext cx="13287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D11c</a:t>
              </a:r>
              <a:r>
                <a:rPr b="1" lang="en-US" sz="8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CD80</a:t>
              </a:r>
              <a:r>
                <a:rPr b="1" lang="en-US" sz="8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x10</a:t>
              </a:r>
              <a:r>
                <a:rPr b="1" lang="en-US" sz="8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4 </a:t>
              </a: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IMFI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31" name="Group 186"/>
          <p:cNvGrpSpPr/>
          <p:nvPr/>
        </p:nvGrpSpPr>
        <p:grpSpPr>
          <a:xfrm>
            <a:off x="2328840" y="4361040"/>
            <a:ext cx="2360520" cy="1814040"/>
            <a:chOff x="2328840" y="4361040"/>
            <a:chExt cx="2360520" cy="1814040"/>
          </a:xfrm>
        </p:grpSpPr>
        <p:pic>
          <p:nvPicPr>
            <p:cNvPr id="132" name="Chart 187" descr=""/>
            <p:cNvPicPr/>
            <p:nvPr/>
          </p:nvPicPr>
          <p:blipFill>
            <a:blip r:embed="rId7"/>
            <a:stretch/>
          </p:blipFill>
          <p:spPr>
            <a:xfrm>
              <a:off x="2444400" y="4541400"/>
              <a:ext cx="1993320" cy="1572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33" name="TextBox 23"/>
            <p:cNvSpPr/>
            <p:nvPr/>
          </p:nvSpPr>
          <p:spPr>
            <a:xfrm>
              <a:off x="2776680" y="5974200"/>
              <a:ext cx="5634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Untreated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TextBox 24"/>
            <p:cNvSpPr/>
            <p:nvPr/>
          </p:nvSpPr>
          <p:spPr>
            <a:xfrm>
              <a:off x="3246120" y="5973120"/>
              <a:ext cx="3970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D4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TextBox 25"/>
            <p:cNvSpPr/>
            <p:nvPr/>
          </p:nvSpPr>
          <p:spPr>
            <a:xfrm>
              <a:off x="3520440" y="5974560"/>
              <a:ext cx="4366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TLR-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TextBox 26"/>
            <p:cNvSpPr/>
            <p:nvPr/>
          </p:nvSpPr>
          <p:spPr>
            <a:xfrm>
              <a:off x="3823200" y="5968440"/>
              <a:ext cx="4597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40.T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TextBox 27"/>
            <p:cNvSpPr/>
            <p:nvPr/>
          </p:nvSpPr>
          <p:spPr>
            <a:xfrm>
              <a:off x="4155120" y="5965560"/>
              <a:ext cx="5342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sotype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Straight Connector 193"/>
            <p:cNvSpPr/>
            <p:nvPr/>
          </p:nvSpPr>
          <p:spPr>
            <a:xfrm>
              <a:off x="2997000" y="4565520"/>
              <a:ext cx="9586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TextBox 134"/>
            <p:cNvSpPr/>
            <p:nvPr/>
          </p:nvSpPr>
          <p:spPr>
            <a:xfrm>
              <a:off x="3219480" y="4361040"/>
              <a:ext cx="308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**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Straight Connector 195"/>
            <p:cNvSpPr/>
            <p:nvPr/>
          </p:nvSpPr>
          <p:spPr>
            <a:xfrm>
              <a:off x="3632040" y="4783320"/>
              <a:ext cx="3268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TextBox 138"/>
            <p:cNvSpPr/>
            <p:nvPr/>
          </p:nvSpPr>
          <p:spPr>
            <a:xfrm>
              <a:off x="3667320" y="4590000"/>
              <a:ext cx="308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**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TextBox 153"/>
            <p:cNvSpPr/>
            <p:nvPr/>
          </p:nvSpPr>
          <p:spPr>
            <a:xfrm rot="16200000">
              <a:off x="1707120" y="5148360"/>
              <a:ext cx="15807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D11c</a:t>
              </a:r>
              <a:r>
                <a:rPr b="1" lang="en-US" sz="8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+ </a:t>
              </a: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D86</a:t>
              </a:r>
              <a:r>
                <a:rPr b="1" lang="en-US" sz="8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x 10</a:t>
              </a:r>
              <a:r>
                <a:rPr b="1" lang="en-US" sz="8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IMFI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43" name="Group 198"/>
          <p:cNvGrpSpPr/>
          <p:nvPr/>
        </p:nvGrpSpPr>
        <p:grpSpPr>
          <a:xfrm>
            <a:off x="4419720" y="4476600"/>
            <a:ext cx="2438280" cy="1699920"/>
            <a:chOff x="4419720" y="4476600"/>
            <a:chExt cx="2438280" cy="1699920"/>
          </a:xfrm>
        </p:grpSpPr>
        <p:pic>
          <p:nvPicPr>
            <p:cNvPr id="144" name="Chart 199" descr=""/>
            <p:cNvPicPr/>
            <p:nvPr/>
          </p:nvPicPr>
          <p:blipFill>
            <a:blip r:embed="rId8"/>
            <a:stretch/>
          </p:blipFill>
          <p:spPr>
            <a:xfrm>
              <a:off x="4718160" y="4724280"/>
              <a:ext cx="1859400" cy="1402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45" name="TextBox 23"/>
            <p:cNvSpPr/>
            <p:nvPr/>
          </p:nvSpPr>
          <p:spPr>
            <a:xfrm>
              <a:off x="4816800" y="5970600"/>
              <a:ext cx="5634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Untreated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TextBox 24"/>
            <p:cNvSpPr/>
            <p:nvPr/>
          </p:nvSpPr>
          <p:spPr>
            <a:xfrm>
              <a:off x="5315760" y="5969520"/>
              <a:ext cx="3970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D4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TextBox 25"/>
            <p:cNvSpPr/>
            <p:nvPr/>
          </p:nvSpPr>
          <p:spPr>
            <a:xfrm>
              <a:off x="5635800" y="5970960"/>
              <a:ext cx="4366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TLR-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TextBox 26"/>
            <p:cNvSpPr/>
            <p:nvPr/>
          </p:nvSpPr>
          <p:spPr>
            <a:xfrm>
              <a:off x="5983200" y="5976000"/>
              <a:ext cx="4597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40.T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TextBox 27"/>
            <p:cNvSpPr/>
            <p:nvPr/>
          </p:nvSpPr>
          <p:spPr>
            <a:xfrm>
              <a:off x="6303240" y="5969520"/>
              <a:ext cx="5547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sotype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Straight Connector 205"/>
            <p:cNvSpPr/>
            <p:nvPr/>
          </p:nvSpPr>
          <p:spPr>
            <a:xfrm>
              <a:off x="5167440" y="4665240"/>
              <a:ext cx="8539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TextBox 162"/>
            <p:cNvSpPr/>
            <p:nvPr/>
          </p:nvSpPr>
          <p:spPr>
            <a:xfrm>
              <a:off x="5473080" y="4476600"/>
              <a:ext cx="308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**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TextBox 163"/>
            <p:cNvSpPr/>
            <p:nvPr/>
          </p:nvSpPr>
          <p:spPr>
            <a:xfrm rot="16200000">
              <a:off x="4039200" y="5177520"/>
              <a:ext cx="10980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D11c</a:t>
              </a:r>
              <a:r>
                <a:rPr b="1" lang="en-US" sz="8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+ </a:t>
              </a: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HCII</a:t>
              </a:r>
              <a:r>
                <a:rPr b="1" lang="en-US" sz="8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x10</a:t>
              </a:r>
              <a:r>
                <a:rPr b="1" lang="en-US" sz="8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IMFI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Straight Connector 208"/>
            <p:cNvSpPr/>
            <p:nvPr/>
          </p:nvSpPr>
          <p:spPr>
            <a:xfrm>
              <a:off x="5477040" y="4802040"/>
              <a:ext cx="598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Straight Connector 209"/>
            <p:cNvSpPr/>
            <p:nvPr/>
          </p:nvSpPr>
          <p:spPr>
            <a:xfrm>
              <a:off x="5673960" y="4902120"/>
              <a:ext cx="426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TextBox 162"/>
            <p:cNvSpPr/>
            <p:nvPr/>
          </p:nvSpPr>
          <p:spPr>
            <a:xfrm>
              <a:off x="5627160" y="467892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TextBox 162"/>
            <p:cNvSpPr/>
            <p:nvPr/>
          </p:nvSpPr>
          <p:spPr>
            <a:xfrm>
              <a:off x="5761800" y="477216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57" name="Text Box 28"/>
          <p:cNvSpPr/>
          <p:nvPr/>
        </p:nvSpPr>
        <p:spPr>
          <a:xfrm>
            <a:off x="304920" y="4284720"/>
            <a:ext cx="269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Text Box 28"/>
          <p:cNvSpPr/>
          <p:nvPr/>
        </p:nvSpPr>
        <p:spPr>
          <a:xfrm>
            <a:off x="2438280" y="4284720"/>
            <a:ext cx="26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Text Box 28"/>
          <p:cNvSpPr/>
          <p:nvPr/>
        </p:nvSpPr>
        <p:spPr>
          <a:xfrm>
            <a:off x="4287960" y="4267080"/>
            <a:ext cx="284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0" name="Group 37"/>
          <p:cNvGrpSpPr/>
          <p:nvPr/>
        </p:nvGrpSpPr>
        <p:grpSpPr>
          <a:xfrm>
            <a:off x="228600" y="399960"/>
            <a:ext cx="6592320" cy="2844720"/>
            <a:chOff x="228600" y="399960"/>
            <a:chExt cx="6592320" cy="2844720"/>
          </a:xfrm>
        </p:grpSpPr>
        <p:pic>
          <p:nvPicPr>
            <p:cNvPr id="161" name="Chart 3" descr=""/>
            <p:cNvPicPr/>
            <p:nvPr/>
          </p:nvPicPr>
          <p:blipFill>
            <a:blip r:embed="rId1"/>
            <a:stretch/>
          </p:blipFill>
          <p:spPr>
            <a:xfrm>
              <a:off x="3352680" y="737280"/>
              <a:ext cx="3364920" cy="2408040"/>
            </a:xfrm>
            <a:prstGeom prst="rect">
              <a:avLst/>
            </a:prstGeom>
            <a:ln w="0">
              <a:noFill/>
            </a:ln>
          </p:spPr>
        </p:pic>
        <p:graphicFrame>
          <p:nvGraphicFramePr>
            <p:cNvPr id="162" name="Object 3"/>
            <p:cNvGraphicFramePr/>
            <p:nvPr/>
          </p:nvGraphicFramePr>
          <p:xfrm>
            <a:off x="463680" y="798480"/>
            <a:ext cx="2889000" cy="2085480"/>
          </p:xfrm>
          <a:graphic>
            <a:graphicData uri="http://schemas.openxmlformats.org/presentationml/2006/ole">
              <p:oleObj progId="Excel.Sheet.12" r:id="rId2" spid="">
                <p:embed/>
                <p:pic>
                  <p:nvPicPr>
                    <p:cNvPr id="163" name="Object 3" descr=""/>
                    <p:cNvPicPr/>
                    <p:nvPr/>
                  </p:nvPicPr>
                  <p:blipFill>
                    <a:blip r:embed="rId3"/>
                    <a:stretch/>
                  </p:blipFill>
                  <p:spPr>
                    <a:xfrm>
                      <a:off x="463680" y="798480"/>
                      <a:ext cx="2889000" cy="20854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164" name="TextBox 7"/>
            <p:cNvSpPr/>
            <p:nvPr/>
          </p:nvSpPr>
          <p:spPr>
            <a:xfrm rot="16200000">
              <a:off x="-71280" y="1641960"/>
              <a:ext cx="846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L-6 (pg/ml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Straight Connector 9"/>
            <p:cNvSpPr/>
            <p:nvPr/>
          </p:nvSpPr>
          <p:spPr>
            <a:xfrm>
              <a:off x="1182600" y="949320"/>
              <a:ext cx="1407960" cy="0"/>
            </a:xfrm>
            <a:prstGeom prst="line">
              <a:avLst/>
            </a:prstGeom>
            <a:ln w="936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TextBox 10"/>
            <p:cNvSpPr/>
            <p:nvPr/>
          </p:nvSpPr>
          <p:spPr>
            <a:xfrm>
              <a:off x="1676160" y="786240"/>
              <a:ext cx="430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*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Straight Connector 12"/>
            <p:cNvSpPr/>
            <p:nvPr/>
          </p:nvSpPr>
          <p:spPr>
            <a:xfrm>
              <a:off x="4143240" y="871200"/>
              <a:ext cx="1876320" cy="0"/>
            </a:xfrm>
            <a:prstGeom prst="line">
              <a:avLst/>
            </a:prstGeom>
            <a:ln w="936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TextBox 13"/>
            <p:cNvSpPr/>
            <p:nvPr/>
          </p:nvSpPr>
          <p:spPr>
            <a:xfrm>
              <a:off x="4874400" y="71100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Straight Connector 19"/>
            <p:cNvSpPr/>
            <p:nvPr/>
          </p:nvSpPr>
          <p:spPr>
            <a:xfrm>
              <a:off x="4552920" y="2967120"/>
              <a:ext cx="2065320" cy="0"/>
            </a:xfrm>
            <a:prstGeom prst="line">
              <a:avLst/>
            </a:prstGeom>
            <a:ln w="936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TextBox 20"/>
            <p:cNvSpPr/>
            <p:nvPr/>
          </p:nvSpPr>
          <p:spPr>
            <a:xfrm>
              <a:off x="5243040" y="2998440"/>
              <a:ext cx="624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nfecte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71" name="Group 30"/>
            <p:cNvGrpSpPr/>
            <p:nvPr/>
          </p:nvGrpSpPr>
          <p:grpSpPr>
            <a:xfrm>
              <a:off x="837000" y="2637000"/>
              <a:ext cx="2554560" cy="259920"/>
              <a:chOff x="837000" y="2637000"/>
              <a:chExt cx="2554560" cy="259920"/>
            </a:xfrm>
          </p:grpSpPr>
          <p:sp>
            <p:nvSpPr>
              <p:cNvPr id="172" name="TextBox 25"/>
              <p:cNvSpPr/>
              <p:nvPr/>
            </p:nvSpPr>
            <p:spPr>
              <a:xfrm>
                <a:off x="837000" y="2637000"/>
                <a:ext cx="3560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UT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TextBox 26"/>
              <p:cNvSpPr/>
              <p:nvPr/>
            </p:nvSpPr>
            <p:spPr>
              <a:xfrm>
                <a:off x="1355040" y="2637000"/>
                <a:ext cx="4917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D4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TextBox 27"/>
              <p:cNvSpPr/>
              <p:nvPr/>
            </p:nvSpPr>
            <p:spPr>
              <a:xfrm>
                <a:off x="1801800" y="2637000"/>
                <a:ext cx="5464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TLR-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TextBox 28"/>
              <p:cNvSpPr/>
              <p:nvPr/>
            </p:nvSpPr>
            <p:spPr>
              <a:xfrm>
                <a:off x="2278800" y="2637000"/>
                <a:ext cx="5799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40.T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TextBox 29"/>
              <p:cNvSpPr/>
              <p:nvPr/>
            </p:nvSpPr>
            <p:spPr>
              <a:xfrm>
                <a:off x="2816280" y="2650680"/>
                <a:ext cx="575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Isotyp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77" name="Group 31"/>
            <p:cNvGrpSpPr/>
            <p:nvPr/>
          </p:nvGrpSpPr>
          <p:grpSpPr>
            <a:xfrm>
              <a:off x="4396680" y="2739600"/>
              <a:ext cx="2424240" cy="246240"/>
              <a:chOff x="4396680" y="2739600"/>
              <a:chExt cx="2424240" cy="246240"/>
            </a:xfrm>
          </p:grpSpPr>
          <p:sp>
            <p:nvSpPr>
              <p:cNvPr id="178" name="TextBox 32"/>
              <p:cNvSpPr/>
              <p:nvPr/>
            </p:nvSpPr>
            <p:spPr>
              <a:xfrm>
                <a:off x="4396680" y="2739600"/>
                <a:ext cx="3560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UT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TextBox 33"/>
              <p:cNvSpPr/>
              <p:nvPr/>
            </p:nvSpPr>
            <p:spPr>
              <a:xfrm>
                <a:off x="4855320" y="2739600"/>
                <a:ext cx="4917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D4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TextBox 34"/>
              <p:cNvSpPr/>
              <p:nvPr/>
            </p:nvSpPr>
            <p:spPr>
              <a:xfrm>
                <a:off x="5293080" y="2739600"/>
                <a:ext cx="5464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TLR-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TextBox 35"/>
              <p:cNvSpPr/>
              <p:nvPr/>
            </p:nvSpPr>
            <p:spPr>
              <a:xfrm>
                <a:off x="5767920" y="2739600"/>
                <a:ext cx="5799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40.T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TextBox 36"/>
              <p:cNvSpPr/>
              <p:nvPr/>
            </p:nvSpPr>
            <p:spPr>
              <a:xfrm>
                <a:off x="6245640" y="2739600"/>
                <a:ext cx="575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Isotyp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83" name="TextBox 37"/>
            <p:cNvSpPr/>
            <p:nvPr/>
          </p:nvSpPr>
          <p:spPr>
            <a:xfrm>
              <a:off x="3999960" y="273960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U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TextBox 45"/>
            <p:cNvSpPr/>
            <p:nvPr/>
          </p:nvSpPr>
          <p:spPr>
            <a:xfrm>
              <a:off x="475560" y="399960"/>
              <a:ext cx="308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TextBox 46"/>
            <p:cNvSpPr/>
            <p:nvPr/>
          </p:nvSpPr>
          <p:spPr>
            <a:xfrm>
              <a:off x="3211200" y="399960"/>
              <a:ext cx="2995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86" name="Group 39"/>
          <p:cNvGrpSpPr/>
          <p:nvPr/>
        </p:nvGrpSpPr>
        <p:grpSpPr>
          <a:xfrm>
            <a:off x="1465200" y="3429000"/>
            <a:ext cx="3219840" cy="2895480"/>
            <a:chOff x="1465200" y="3429000"/>
            <a:chExt cx="3219840" cy="2895480"/>
          </a:xfrm>
        </p:grpSpPr>
        <p:pic>
          <p:nvPicPr>
            <p:cNvPr id="187" name="Chart 24" descr=""/>
            <p:cNvPicPr/>
            <p:nvPr/>
          </p:nvPicPr>
          <p:blipFill>
            <a:blip r:embed="rId4"/>
            <a:stretch/>
          </p:blipFill>
          <p:spPr>
            <a:xfrm>
              <a:off x="1530000" y="3657240"/>
              <a:ext cx="3047760" cy="2667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88" name="Straight Connector 22"/>
            <p:cNvSpPr/>
            <p:nvPr/>
          </p:nvSpPr>
          <p:spPr>
            <a:xfrm>
              <a:off x="2535120" y="4298040"/>
              <a:ext cx="1350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TextBox 23"/>
            <p:cNvSpPr/>
            <p:nvPr/>
          </p:nvSpPr>
          <p:spPr>
            <a:xfrm>
              <a:off x="3157200" y="4105080"/>
              <a:ext cx="257040" cy="276480"/>
            </a:xfrm>
            <a:prstGeom prst="rect">
              <a:avLst/>
            </a:prstGeom>
            <a:noFill/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90" name="Group 38"/>
            <p:cNvGrpSpPr/>
            <p:nvPr/>
          </p:nvGrpSpPr>
          <p:grpSpPr>
            <a:xfrm>
              <a:off x="2306160" y="5900400"/>
              <a:ext cx="2378880" cy="257400"/>
              <a:chOff x="2306160" y="5900400"/>
              <a:chExt cx="2378880" cy="257400"/>
            </a:xfrm>
          </p:grpSpPr>
          <p:sp>
            <p:nvSpPr>
              <p:cNvPr id="191" name="TextBox 39"/>
              <p:cNvSpPr/>
              <p:nvPr/>
            </p:nvSpPr>
            <p:spPr>
              <a:xfrm>
                <a:off x="2306160" y="5911560"/>
                <a:ext cx="3560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UT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TextBox 40"/>
              <p:cNvSpPr/>
              <p:nvPr/>
            </p:nvSpPr>
            <p:spPr>
              <a:xfrm>
                <a:off x="2594880" y="5900400"/>
                <a:ext cx="5558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D4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TextBox 41"/>
              <p:cNvSpPr/>
              <p:nvPr/>
            </p:nvSpPr>
            <p:spPr>
              <a:xfrm>
                <a:off x="3080520" y="5900400"/>
                <a:ext cx="5464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TLR-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TextBox 42"/>
              <p:cNvSpPr/>
              <p:nvPr/>
            </p:nvSpPr>
            <p:spPr>
              <a:xfrm>
                <a:off x="3512520" y="5911560"/>
                <a:ext cx="6440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40.T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TextBox 43"/>
              <p:cNvSpPr/>
              <p:nvPr/>
            </p:nvSpPr>
            <p:spPr>
              <a:xfrm>
                <a:off x="3949560" y="5900400"/>
                <a:ext cx="7354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   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Isotyp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96" name="TextBox 47"/>
            <p:cNvSpPr/>
            <p:nvPr/>
          </p:nvSpPr>
          <p:spPr>
            <a:xfrm>
              <a:off x="1465200" y="3429000"/>
              <a:ext cx="308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97" name="TextBox 39"/>
          <p:cNvSpPr/>
          <p:nvPr/>
        </p:nvSpPr>
        <p:spPr>
          <a:xfrm>
            <a:off x="114480" y="6908760"/>
            <a:ext cx="6686280" cy="198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200000"/>
              </a:lnSpc>
              <a:spcBef>
                <a:spcPts val="499"/>
              </a:spcBef>
              <a:spcAft>
                <a:spcPts val="499"/>
              </a:spcAft>
              <a:tabLst>
                <a:tab algn="l" pos="0"/>
                <a:tab algn="l" pos="57240"/>
                <a:tab algn="l" pos="114480"/>
                <a:tab algn="l" pos="228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809960"/>
                <a:tab algn="l" pos="103924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2. Signaling delivered through C40.T4 induced the activation of bone marrow derived macrophages (BMDMs). (A) BMDMs were stimulated with C40.T4 for 12h. Later, IL-6 was detected in culture SNs by ELISA; (B)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tb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infected BMDMs were stimulated with C40.T4 for 24h. Later, IL-6 was estimated in the culture SNs and (C) cells were lysed and plating was done to enumerate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tb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by CFUs on 21d. Data represented as mean±SD are of two independent experiments. ‘*’ and ‘**’, indicate  p&lt;0.05 and p&lt;0.01, respectively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200000"/>
              </a:lnSpc>
              <a:tabLst>
                <a:tab algn="l" pos="0"/>
                <a:tab algn="l" pos="57240"/>
                <a:tab algn="l" pos="114480"/>
                <a:tab algn="l" pos="228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809960"/>
                <a:tab algn="l" pos="10392408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TextBox 38"/>
          <p:cNvSpPr/>
          <p:nvPr/>
        </p:nvSpPr>
        <p:spPr>
          <a:xfrm>
            <a:off x="59400" y="101520"/>
            <a:ext cx="964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2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9" name="Picture 34" descr=""/>
          <p:cNvPicPr/>
          <p:nvPr/>
        </p:nvPicPr>
        <p:blipFill>
          <a:blip r:embed="rId1"/>
          <a:srcRect l="12370" t="0" r="10955" b="0"/>
          <a:stretch/>
        </p:blipFill>
        <p:spPr>
          <a:xfrm>
            <a:off x="914400" y="3581280"/>
            <a:ext cx="2362320" cy="3409920"/>
          </a:xfrm>
          <a:prstGeom prst="rect">
            <a:avLst/>
          </a:prstGeom>
          <a:ln w="0">
            <a:noFill/>
          </a:ln>
        </p:spPr>
      </p:pic>
      <p:pic>
        <p:nvPicPr>
          <p:cNvPr id="200" name="Chart 1" descr=""/>
          <p:cNvPicPr/>
          <p:nvPr/>
        </p:nvPicPr>
        <p:blipFill>
          <a:blip r:embed="rId2"/>
          <a:stretch/>
        </p:blipFill>
        <p:spPr>
          <a:xfrm>
            <a:off x="3340080" y="1146240"/>
            <a:ext cx="2567160" cy="2212920"/>
          </a:xfrm>
          <a:prstGeom prst="rect">
            <a:avLst/>
          </a:prstGeom>
          <a:ln w="0">
            <a:noFill/>
          </a:ln>
        </p:spPr>
      </p:pic>
      <p:sp>
        <p:nvSpPr>
          <p:cNvPr id="201" name="Rectangle 42"/>
          <p:cNvSpPr/>
          <p:nvPr/>
        </p:nvSpPr>
        <p:spPr>
          <a:xfrm rot="16200000">
            <a:off x="2811240" y="2337840"/>
            <a:ext cx="1195560" cy="239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U/mlX10</a:t>
            </a:r>
            <a:r>
              <a:rPr b="1" lang="en-US" sz="9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TextBox 27"/>
          <p:cNvSpPr/>
          <p:nvPr/>
        </p:nvSpPr>
        <p:spPr>
          <a:xfrm>
            <a:off x="5094360" y="1981080"/>
            <a:ext cx="347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TextBox 34"/>
          <p:cNvSpPr/>
          <p:nvPr/>
        </p:nvSpPr>
        <p:spPr>
          <a:xfrm>
            <a:off x="3338640" y="1149480"/>
            <a:ext cx="401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Rectangle 90"/>
          <p:cNvSpPr/>
          <p:nvPr/>
        </p:nvSpPr>
        <p:spPr>
          <a:xfrm>
            <a:off x="4286160" y="3124080"/>
            <a:ext cx="3938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D4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Rectangle 91"/>
          <p:cNvSpPr/>
          <p:nvPr/>
        </p:nvSpPr>
        <p:spPr>
          <a:xfrm>
            <a:off x="4603680" y="3124080"/>
            <a:ext cx="4651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LR-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Rectangle 92"/>
          <p:cNvSpPr/>
          <p:nvPr/>
        </p:nvSpPr>
        <p:spPr>
          <a:xfrm>
            <a:off x="5011560" y="3124080"/>
            <a:ext cx="5065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40.T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Rectangle 93"/>
          <p:cNvSpPr/>
          <p:nvPr/>
        </p:nvSpPr>
        <p:spPr>
          <a:xfrm>
            <a:off x="5518080" y="3124080"/>
            <a:ext cx="5018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sotype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Rectangle 90"/>
          <p:cNvSpPr/>
          <p:nvPr/>
        </p:nvSpPr>
        <p:spPr>
          <a:xfrm>
            <a:off x="3846600" y="3124080"/>
            <a:ext cx="2239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UT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09" name="Group 105"/>
          <p:cNvGrpSpPr/>
          <p:nvPr/>
        </p:nvGrpSpPr>
        <p:grpSpPr>
          <a:xfrm>
            <a:off x="494280" y="1208160"/>
            <a:ext cx="2444400" cy="2248920"/>
            <a:chOff x="494280" y="1208160"/>
            <a:chExt cx="2444400" cy="2248920"/>
          </a:xfrm>
        </p:grpSpPr>
        <p:grpSp>
          <p:nvGrpSpPr>
            <p:cNvPr id="210" name="Group 51"/>
            <p:cNvGrpSpPr/>
            <p:nvPr/>
          </p:nvGrpSpPr>
          <p:grpSpPr>
            <a:xfrm>
              <a:off x="494280" y="1208160"/>
              <a:ext cx="2444400" cy="2248920"/>
              <a:chOff x="494280" y="1208160"/>
              <a:chExt cx="2444400" cy="2248920"/>
            </a:xfrm>
          </p:grpSpPr>
          <p:pic>
            <p:nvPicPr>
              <p:cNvPr id="211" name="Picture 11" descr=""/>
              <p:cNvPicPr/>
              <p:nvPr/>
            </p:nvPicPr>
            <p:blipFill>
              <a:blip r:embed="rId3"/>
              <a:srcRect l="30400" t="35203" r="33606" b="48813"/>
              <a:stretch/>
            </p:blipFill>
            <p:spPr>
              <a:xfrm>
                <a:off x="938520" y="2634120"/>
                <a:ext cx="1651680" cy="2944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12" name="Picture 12" descr=""/>
              <p:cNvPicPr/>
              <p:nvPr/>
            </p:nvPicPr>
            <p:blipFill>
              <a:blip r:embed="rId4"/>
              <a:srcRect l="30400" t="54408" r="33606" b="29608"/>
              <a:stretch/>
            </p:blipFill>
            <p:spPr>
              <a:xfrm>
                <a:off x="938520" y="2988000"/>
                <a:ext cx="1651680" cy="1767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13" name="Text Box 13"/>
              <p:cNvSpPr/>
              <p:nvPr/>
            </p:nvSpPr>
            <p:spPr>
              <a:xfrm>
                <a:off x="494280" y="3223800"/>
                <a:ext cx="7264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iNOs/Actin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Text Box 14"/>
              <p:cNvSpPr/>
              <p:nvPr/>
            </p:nvSpPr>
            <p:spPr>
              <a:xfrm>
                <a:off x="1101240" y="3215520"/>
                <a:ext cx="2386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Text Box 15"/>
              <p:cNvSpPr/>
              <p:nvPr/>
            </p:nvSpPr>
            <p:spPr>
              <a:xfrm>
                <a:off x="1288440" y="3215520"/>
                <a:ext cx="3254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.2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Text Box 16"/>
              <p:cNvSpPr/>
              <p:nvPr/>
            </p:nvSpPr>
            <p:spPr>
              <a:xfrm>
                <a:off x="1608120" y="3225960"/>
                <a:ext cx="3254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.3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Text Box 17"/>
              <p:cNvSpPr/>
              <p:nvPr/>
            </p:nvSpPr>
            <p:spPr>
              <a:xfrm>
                <a:off x="1927800" y="3223440"/>
                <a:ext cx="3254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.4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Text Box 18"/>
              <p:cNvSpPr/>
              <p:nvPr/>
            </p:nvSpPr>
            <p:spPr>
              <a:xfrm>
                <a:off x="2302200" y="3223800"/>
                <a:ext cx="3254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.8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Text Box 23"/>
              <p:cNvSpPr/>
              <p:nvPr/>
            </p:nvSpPr>
            <p:spPr>
              <a:xfrm rot="18270000">
                <a:off x="728640" y="2138040"/>
                <a:ext cx="973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Uninfecte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Text Box 26"/>
              <p:cNvSpPr/>
              <p:nvPr/>
            </p:nvSpPr>
            <p:spPr>
              <a:xfrm rot="18270000">
                <a:off x="1458000" y="2202480"/>
                <a:ext cx="722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D4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" name="Text Box 27"/>
              <p:cNvSpPr/>
              <p:nvPr/>
            </p:nvSpPr>
            <p:spPr>
              <a:xfrm rot="18270000">
                <a:off x="1763280" y="2274840"/>
                <a:ext cx="677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TLR-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" name="Text Box 28"/>
              <p:cNvSpPr/>
              <p:nvPr/>
            </p:nvSpPr>
            <p:spPr>
              <a:xfrm rot="18270000">
                <a:off x="2044440" y="2105280"/>
                <a:ext cx="96408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40.T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" name="Text Box 24"/>
              <p:cNvSpPr/>
              <p:nvPr/>
            </p:nvSpPr>
            <p:spPr>
              <a:xfrm>
                <a:off x="592560" y="2638440"/>
                <a:ext cx="4276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iNOs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" name="Text Box 25"/>
              <p:cNvSpPr/>
              <p:nvPr/>
            </p:nvSpPr>
            <p:spPr>
              <a:xfrm>
                <a:off x="592200" y="2957760"/>
                <a:ext cx="42300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actin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" name="TextBox 32"/>
              <p:cNvSpPr/>
              <p:nvPr/>
            </p:nvSpPr>
            <p:spPr>
              <a:xfrm>
                <a:off x="744480" y="1208160"/>
                <a:ext cx="2905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" name="Text Box 23"/>
              <p:cNvSpPr/>
              <p:nvPr/>
            </p:nvSpPr>
            <p:spPr>
              <a:xfrm rot="18270000">
                <a:off x="1059120" y="2061360"/>
                <a:ext cx="11570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Untreate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27" name="Straight Connector 12"/>
            <p:cNvSpPr/>
            <p:nvPr/>
          </p:nvSpPr>
          <p:spPr>
            <a:xfrm>
              <a:off x="1524240" y="2133720"/>
              <a:ext cx="9334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Text Box 23"/>
            <p:cNvSpPr/>
            <p:nvPr/>
          </p:nvSpPr>
          <p:spPr>
            <a:xfrm>
              <a:off x="1524240" y="1930680"/>
              <a:ext cx="8816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nfected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29" name="Rectangle 30"/>
          <p:cNvSpPr/>
          <p:nvPr/>
        </p:nvSpPr>
        <p:spPr>
          <a:xfrm>
            <a:off x="114480" y="6951600"/>
            <a:ext cx="6572160" cy="161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2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3. DCs infected with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tb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were stimulated through C40.T4, CD40, TLR-4 and assessed for  16h  and 24h, respectively (A) iNOS in cell lysate by immunoblotting; (B) CFUs in the presence of iNOS inhibitor n-monomethyl-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arginine on 21d.  DCs were treated with beclin or scrambled  (scr)  siRNA  for 48h. Later, expression  of beclin was detected by RT-qPCR.. Data shown are representative of two independent experiments. Bar graph represents mean±SD. ‘*’ indicate  p&lt;0.05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TextBox 31"/>
          <p:cNvSpPr/>
          <p:nvPr/>
        </p:nvSpPr>
        <p:spPr>
          <a:xfrm>
            <a:off x="59400" y="101520"/>
            <a:ext cx="964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3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TextBox 34"/>
          <p:cNvSpPr/>
          <p:nvPr/>
        </p:nvSpPr>
        <p:spPr>
          <a:xfrm>
            <a:off x="512640" y="3581280"/>
            <a:ext cx="401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Straight Connector 35"/>
          <p:cNvSpPr/>
          <p:nvPr/>
        </p:nvSpPr>
        <p:spPr>
          <a:xfrm>
            <a:off x="1905120" y="4343400"/>
            <a:ext cx="6094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TextBox 36"/>
          <p:cNvSpPr/>
          <p:nvPr/>
        </p:nvSpPr>
        <p:spPr>
          <a:xfrm>
            <a:off x="2090160" y="411480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Rectangle 42"/>
          <p:cNvSpPr/>
          <p:nvPr/>
        </p:nvSpPr>
        <p:spPr>
          <a:xfrm rot="16200000">
            <a:off x="119880" y="4909320"/>
            <a:ext cx="1371600" cy="239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eclin </a:t>
            </a: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mRNA expressio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5" name="Group 23"/>
          <p:cNvGrpSpPr/>
          <p:nvPr/>
        </p:nvGrpSpPr>
        <p:grpSpPr>
          <a:xfrm>
            <a:off x="1277640" y="833400"/>
            <a:ext cx="4056480" cy="4590000"/>
            <a:chOff x="1277640" y="833400"/>
            <a:chExt cx="4056480" cy="4590000"/>
          </a:xfrm>
        </p:grpSpPr>
        <p:pic>
          <p:nvPicPr>
            <p:cNvPr id="236" name="Chart 36" descr=""/>
            <p:cNvPicPr/>
            <p:nvPr/>
          </p:nvPicPr>
          <p:blipFill>
            <a:blip r:embed="rId1"/>
            <a:stretch/>
          </p:blipFill>
          <p:spPr>
            <a:xfrm>
              <a:off x="2340720" y="3395520"/>
              <a:ext cx="2694600" cy="2005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37" name="Chart 35" descr=""/>
            <p:cNvPicPr/>
            <p:nvPr/>
          </p:nvPicPr>
          <p:blipFill>
            <a:blip r:embed="rId2"/>
            <a:stretch/>
          </p:blipFill>
          <p:spPr>
            <a:xfrm>
              <a:off x="2420280" y="1182600"/>
              <a:ext cx="2767680" cy="1938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38" name="Rectangle 92"/>
            <p:cNvSpPr/>
            <p:nvPr/>
          </p:nvSpPr>
          <p:spPr>
            <a:xfrm>
              <a:off x="4339440" y="2992680"/>
              <a:ext cx="994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D4. C40.T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Rectangle 90"/>
            <p:cNvSpPr/>
            <p:nvPr/>
          </p:nvSpPr>
          <p:spPr>
            <a:xfrm>
              <a:off x="3720960" y="3001320"/>
              <a:ext cx="656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D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Rectangle 90"/>
            <p:cNvSpPr/>
            <p:nvPr/>
          </p:nvSpPr>
          <p:spPr>
            <a:xfrm>
              <a:off x="2809080" y="2983680"/>
              <a:ext cx="688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aive CD4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TextBox 9"/>
            <p:cNvSpPr/>
            <p:nvPr/>
          </p:nvSpPr>
          <p:spPr>
            <a:xfrm rot="16200000">
              <a:off x="1874160" y="2028960"/>
              <a:ext cx="926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FU/ml x10</a:t>
              </a:r>
              <a:r>
                <a:rPr b="1" lang="en-US" sz="10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Straight Connector 11"/>
            <p:cNvSpPr/>
            <p:nvPr/>
          </p:nvSpPr>
          <p:spPr>
            <a:xfrm>
              <a:off x="3038400" y="1403280"/>
              <a:ext cx="17445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TextBox 27"/>
            <p:cNvSpPr/>
            <p:nvPr/>
          </p:nvSpPr>
          <p:spPr>
            <a:xfrm>
              <a:off x="3930840" y="1254960"/>
              <a:ext cx="333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*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TextBox 28"/>
            <p:cNvSpPr/>
            <p:nvPr/>
          </p:nvSpPr>
          <p:spPr>
            <a:xfrm>
              <a:off x="4223160" y="165744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Straight Connector 15"/>
            <p:cNvSpPr/>
            <p:nvPr/>
          </p:nvSpPr>
          <p:spPr>
            <a:xfrm>
              <a:off x="3880080" y="1798560"/>
              <a:ext cx="8254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TextBox 43"/>
            <p:cNvSpPr/>
            <p:nvPr/>
          </p:nvSpPr>
          <p:spPr>
            <a:xfrm>
              <a:off x="1866240" y="1115280"/>
              <a:ext cx="29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Rectangle 92"/>
            <p:cNvSpPr/>
            <p:nvPr/>
          </p:nvSpPr>
          <p:spPr>
            <a:xfrm>
              <a:off x="4216680" y="5261760"/>
              <a:ext cx="964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40.T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Rectangle 90"/>
            <p:cNvSpPr/>
            <p:nvPr/>
          </p:nvSpPr>
          <p:spPr>
            <a:xfrm>
              <a:off x="3634920" y="5252760"/>
              <a:ext cx="637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D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Rectangle 90"/>
            <p:cNvSpPr/>
            <p:nvPr/>
          </p:nvSpPr>
          <p:spPr>
            <a:xfrm>
              <a:off x="2656080" y="5270760"/>
              <a:ext cx="765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aive CD8 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TextBox 9"/>
            <p:cNvSpPr/>
            <p:nvPr/>
          </p:nvSpPr>
          <p:spPr>
            <a:xfrm rot="16200000">
              <a:off x="1805400" y="4156920"/>
              <a:ext cx="945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FU/ml x10</a:t>
              </a:r>
              <a:r>
                <a:rPr b="1" lang="en-US" sz="10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TextBox 44"/>
            <p:cNvSpPr/>
            <p:nvPr/>
          </p:nvSpPr>
          <p:spPr>
            <a:xfrm>
              <a:off x="1864800" y="3114360"/>
              <a:ext cx="282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TextBox 10"/>
            <p:cNvSpPr/>
            <p:nvPr/>
          </p:nvSpPr>
          <p:spPr>
            <a:xfrm>
              <a:off x="1277640" y="833400"/>
              <a:ext cx="919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Figure S4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TextBox 28"/>
            <p:cNvSpPr/>
            <p:nvPr/>
          </p:nvSpPr>
          <p:spPr>
            <a:xfrm>
              <a:off x="4110120" y="365148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Straight Connector 38"/>
            <p:cNvSpPr/>
            <p:nvPr/>
          </p:nvSpPr>
          <p:spPr>
            <a:xfrm>
              <a:off x="3727440" y="3827520"/>
              <a:ext cx="917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Straight Connector 39"/>
            <p:cNvSpPr/>
            <p:nvPr/>
          </p:nvSpPr>
          <p:spPr>
            <a:xfrm>
              <a:off x="2962440" y="3613320"/>
              <a:ext cx="1560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TextBox 27"/>
            <p:cNvSpPr/>
            <p:nvPr/>
          </p:nvSpPr>
          <p:spPr>
            <a:xfrm>
              <a:off x="3710880" y="3452400"/>
              <a:ext cx="333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*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57" name="Rectangle 1"/>
          <p:cNvSpPr/>
          <p:nvPr/>
        </p:nvSpPr>
        <p:spPr>
          <a:xfrm>
            <a:off x="0" y="6256800"/>
            <a:ext cx="6915240" cy="19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lnSpc>
                <a:spcPct val="200000"/>
              </a:lnSpc>
              <a:tabLst>
                <a:tab algn="l" pos="0"/>
                <a:tab algn="l" pos="57240"/>
                <a:tab algn="l" pos="114480"/>
                <a:tab algn="l" pos="228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809960"/>
                <a:tab algn="l" pos="103924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4. CD4 and CD8 T cells co-cultured with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tb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infected DCs showed reduction in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tb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rvival. CD4 and CD8 T cells  were purified from C40.T4 treated and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tb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challenged mice. Later, (A) CD4;  (B) CD8 T cells were co-cultured with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tb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infected DCs at a ratio of 10:1. After 48h, cells were lysed and survival of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tb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was checked by CFUs plating. Labeling of ‘x’ axis signifies CD4 or CD8 indicates CD4 or CD8 T cells isolated from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tb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challenged mice; CD4.C40.T4 or CD8.C40A.T4L indicates CD4 or CD8 T cells isolated from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tb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challenged and C40.T4 treated mice. Data represented as mean ±SEM. ‘*’, ‘**’ indicate p&lt;0.05, p&lt;0.01, respectively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96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4-25T22:35:33Z</dcterms:created>
  <dc:creator>Z210</dc:creator>
  <dc:description/>
  <dc:language>en-US</dc:language>
  <cp:lastModifiedBy> </cp:lastModifiedBy>
  <dcterms:modified xsi:type="dcterms:W3CDTF">2016-09-20T06:40:21Z</dcterms:modified>
  <cp:revision>1417</cp:revision>
  <dc:subject/>
  <dc:title>Slide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hecked Out To">
    <vt:lpwstr/>
  </property>
  <property fmtid="{D5CDD505-2E9C-101B-9397-08002B2CF9AE}" pid="3" name="DocumentId">
    <vt:lpwstr>Presentation 1.ppt</vt:lpwstr>
  </property>
  <property fmtid="{D5CDD505-2E9C-101B-9397-08002B2CF9AE}" pid="4" name="DocumentType">
    <vt:lpwstr>Presentation</vt:lpwstr>
  </property>
  <property fmtid="{D5CDD505-2E9C-101B-9397-08002B2CF9AE}" pid="5" name="FileFormat">
    <vt:lpwstr>PPT</vt:lpwstr>
  </property>
  <property fmtid="{D5CDD505-2E9C-101B-9397-08002B2CF9AE}" pid="6" name="IsDeleted">
    <vt:lpwstr>0</vt:lpwstr>
  </property>
  <property fmtid="{D5CDD505-2E9C-101B-9397-08002B2CF9AE}" pid="7" name="StageName">
    <vt:lpwstr>Author's Proof</vt:lpwstr>
  </property>
  <property fmtid="{D5CDD505-2E9C-101B-9397-08002B2CF9AE}" pid="8" name="TitleName">
    <vt:lpwstr>Presentation 1.ppt</vt:lpwstr>
  </property>
</Properties>
</file>